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180006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3AF9912-CF21-3866-83DC-F60A4266DEEB}" name="monica maria umaña zamora" initials="mmuz" userId="bbf8a37dc2e088d5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D206752-AFE5-43FB-B408-59979576D834}" v="2" dt="2022-11-12T19:06:36.08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1" autoAdjust="0"/>
    <p:restoredTop sz="94660"/>
  </p:normalViewPr>
  <p:slideViewPr>
    <p:cSldViewPr snapToGrid="0">
      <p:cViewPr varScale="1">
        <p:scale>
          <a:sx n="55" d="100"/>
          <a:sy n="55" d="100"/>
        </p:scale>
        <p:origin x="17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nica maria umaña zamora" userId="bbf8a37dc2e088d5" providerId="LiveId" clId="{5D206752-AFE5-43FB-B408-59979576D834}"/>
    <pc:docChg chg="custSel modSld">
      <pc:chgData name="monica maria umaña zamora" userId="bbf8a37dc2e088d5" providerId="LiveId" clId="{5D206752-AFE5-43FB-B408-59979576D834}" dt="2022-11-12T19:07:08.376" v="24" actId="1076"/>
      <pc:docMkLst>
        <pc:docMk/>
      </pc:docMkLst>
      <pc:sldChg chg="addSp delSp modSp mod delCm modCm">
        <pc:chgData name="monica maria umaña zamora" userId="bbf8a37dc2e088d5" providerId="LiveId" clId="{5D206752-AFE5-43FB-B408-59979576D834}" dt="2022-11-12T19:07:08.376" v="24" actId="1076"/>
        <pc:sldMkLst>
          <pc:docMk/>
          <pc:sldMk cId="2207077479" sldId="258"/>
        </pc:sldMkLst>
        <pc:spChg chg="mod">
          <ac:chgData name="monica maria umaña zamora" userId="bbf8a37dc2e088d5" providerId="LiveId" clId="{5D206752-AFE5-43FB-B408-59979576D834}" dt="2022-11-12T19:05:11.424" v="14" actId="207"/>
          <ac:spMkLst>
            <pc:docMk/>
            <pc:sldMk cId="2207077479" sldId="258"/>
            <ac:spMk id="19" creationId="{D9284384-88CB-E599-F67E-8AA4836226D1}"/>
          </ac:spMkLst>
        </pc:spChg>
        <pc:picChg chg="del">
          <ac:chgData name="monica maria umaña zamora" userId="bbf8a37dc2e088d5" providerId="LiveId" clId="{5D206752-AFE5-43FB-B408-59979576D834}" dt="2022-11-12T19:04:01.562" v="3" actId="478"/>
          <ac:picMkLst>
            <pc:docMk/>
            <pc:sldMk cId="2207077479" sldId="258"/>
            <ac:picMk id="4" creationId="{F94E1683-285E-5E5A-42BA-CA06B274CA33}"/>
          </ac:picMkLst>
        </pc:picChg>
        <pc:picChg chg="add mod ord modCrop">
          <ac:chgData name="monica maria umaña zamora" userId="bbf8a37dc2e088d5" providerId="LiveId" clId="{5D206752-AFE5-43FB-B408-59979576D834}" dt="2022-11-12T19:07:08.376" v="24" actId="1076"/>
          <ac:picMkLst>
            <pc:docMk/>
            <pc:sldMk cId="2207077479" sldId="258"/>
            <ac:picMk id="16" creationId="{0C1250E4-30FC-AC19-771D-038BE547208F}"/>
          </ac:picMkLst>
        </pc:picChg>
        <pc:picChg chg="del">
          <ac:chgData name="monica maria umaña zamora" userId="bbf8a37dc2e088d5" providerId="LiveId" clId="{5D206752-AFE5-43FB-B408-59979576D834}" dt="2022-11-12T19:03:59.375" v="1" actId="478"/>
          <ac:picMkLst>
            <pc:docMk/>
            <pc:sldMk cId="2207077479" sldId="258"/>
            <ac:picMk id="17" creationId="{0EBD25B0-E704-89E1-3BFF-3242012CDB54}"/>
          </ac:picMkLst>
        </pc:picChg>
        <pc:picChg chg="add del mod modCrop">
          <ac:chgData name="monica maria umaña zamora" userId="bbf8a37dc2e088d5" providerId="LiveId" clId="{5D206752-AFE5-43FB-B408-59979576D834}" dt="2022-11-12T19:06:42.024" v="19" actId="478"/>
          <ac:picMkLst>
            <pc:docMk/>
            <pc:sldMk cId="2207077479" sldId="258"/>
            <ac:picMk id="18" creationId="{A11724AC-EE67-6C0B-3D4F-667D23EC2BDC}"/>
          </ac:picMkLst>
        </pc:picChg>
      </pc:sldChg>
      <pc:sldChg chg="modSp mod delCm">
        <pc:chgData name="monica maria umaña zamora" userId="bbf8a37dc2e088d5" providerId="LiveId" clId="{5D206752-AFE5-43FB-B408-59979576D834}" dt="2022-11-12T19:05:15.927" v="15" actId="207"/>
        <pc:sldMkLst>
          <pc:docMk/>
          <pc:sldMk cId="389166353" sldId="259"/>
        </pc:sldMkLst>
        <pc:spChg chg="mod">
          <ac:chgData name="monica maria umaña zamora" userId="bbf8a37dc2e088d5" providerId="LiveId" clId="{5D206752-AFE5-43FB-B408-59979576D834}" dt="2022-11-12T19:05:15.927" v="15" actId="207"/>
          <ac:spMkLst>
            <pc:docMk/>
            <pc:sldMk cId="389166353" sldId="259"/>
            <ac:spMk id="9" creationId="{4C002BBC-EF30-0392-BFF1-976628876585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TODO%20susan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TODO%20susan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TODO%20susan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TODO%20susan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TODO%20susan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TODO%20susan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f8a37dc2e088d5/DOCTO/laura%20tfm%20moni/TODO%20susan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13670166229222"/>
          <c:y val="4.6712962962962977E-2"/>
          <c:w val="0.82597440944881895"/>
          <c:h val="0.83196741032370958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TODO susana.xlsx]d10 (2)'!$I$21:$I$32</c:f>
              <c:numCache>
                <c:formatCode>General</c:formatCode>
                <c:ptCount val="12"/>
                <c:pt idx="0">
                  <c:v>4.8049999999999997</c:v>
                </c:pt>
                <c:pt idx="1">
                  <c:v>2.67</c:v>
                </c:pt>
                <c:pt idx="2">
                  <c:v>2.11</c:v>
                </c:pt>
                <c:pt idx="3">
                  <c:v>4.1550000000000002</c:v>
                </c:pt>
                <c:pt idx="4">
                  <c:v>2.15</c:v>
                </c:pt>
                <c:pt idx="5">
                  <c:v>2.06</c:v>
                </c:pt>
                <c:pt idx="6">
                  <c:v>4.8949999999999996</c:v>
                </c:pt>
                <c:pt idx="7">
                  <c:v>1.9400000000000002</c:v>
                </c:pt>
                <c:pt idx="8">
                  <c:v>2.2400000000000002</c:v>
                </c:pt>
                <c:pt idx="9">
                  <c:v>3.2000000000000006</c:v>
                </c:pt>
                <c:pt idx="10">
                  <c:v>1.9400000000000002</c:v>
                </c:pt>
                <c:pt idx="11">
                  <c:v>2.1799999999999997</c:v>
                </c:pt>
              </c:numCache>
            </c:numRef>
          </c:xVal>
          <c:yVal>
            <c:numRef>
              <c:f>'[TODO susana.xlsx]d10 (2)'!$R$21:$R$32</c:f>
              <c:numCache>
                <c:formatCode>General</c:formatCode>
                <c:ptCount val="12"/>
                <c:pt idx="0">
                  <c:v>0.16340169201738983</c:v>
                </c:pt>
                <c:pt idx="1">
                  <c:v>-9.1712217551686778E-2</c:v>
                </c:pt>
                <c:pt idx="2">
                  <c:v>-9.7060414153439023E-2</c:v>
                </c:pt>
                <c:pt idx="3">
                  <c:v>1.1449876416893527</c:v>
                </c:pt>
                <c:pt idx="4">
                  <c:v>-0.11847101509453767</c:v>
                </c:pt>
                <c:pt idx="5">
                  <c:v>-0.29881383325973815</c:v>
                </c:pt>
                <c:pt idx="6">
                  <c:v>-1.4974345892220908</c:v>
                </c:pt>
                <c:pt idx="7">
                  <c:v>-1.18702546351932</c:v>
                </c:pt>
                <c:pt idx="8">
                  <c:v>1.0541285138414516</c:v>
                </c:pt>
                <c:pt idx="9">
                  <c:v>-1.0420878561700075</c:v>
                </c:pt>
                <c:pt idx="10">
                  <c:v>-1.18702546351932</c:v>
                </c:pt>
                <c:pt idx="11">
                  <c:v>-0.210161885777575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34F-4718-B99F-7906C43C57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4537696"/>
        <c:axId val="744527296"/>
      </c:scatterChart>
      <c:valAx>
        <c:axId val="7445376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10 </a:t>
                </a:r>
                <a:r>
                  <a:rPr lang="en-US" sz="1400" baseline="-25000"/>
                  <a:t>calc</a:t>
                </a:r>
                <a:r>
                  <a:rPr lang="en-US" sz="1400"/>
                  <a:t> (</a:t>
                </a:r>
                <a:r>
                  <a:rPr lang="en-US" sz="1400">
                    <a:latin typeface="Calibri" panose="020F0502020204030204" pitchFamily="34" charset="0"/>
                    <a:cs typeface="Calibri" panose="020F0502020204030204" pitchFamily="34" charset="0"/>
                  </a:rPr>
                  <a:t>µm)</a:t>
                </a:r>
                <a:endParaRPr lang="en-US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4527296"/>
        <c:crosses val="autoZero"/>
        <c:crossBetween val="midCat"/>
      </c:valAx>
      <c:valAx>
        <c:axId val="744527296"/>
        <c:scaling>
          <c:orientation val="minMax"/>
          <c:max val="3"/>
          <c:min val="-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Residua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453769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47003499562554"/>
          <c:y val="4.2083333333333355E-2"/>
          <c:w val="0.83630774278215225"/>
          <c:h val="0.83659703995333912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TODO susana.xlsx]d50 (2)'!$K$21:$K$32</c:f>
              <c:numCache>
                <c:formatCode>0.00</c:formatCode>
                <c:ptCount val="12"/>
                <c:pt idx="0">
                  <c:v>14.7471798566232</c:v>
                </c:pt>
                <c:pt idx="1">
                  <c:v>9.1533564632138091</c:v>
                </c:pt>
                <c:pt idx="2">
                  <c:v>3.86900418797965</c:v>
                </c:pt>
                <c:pt idx="3">
                  <c:v>11.165376894639399</c:v>
                </c:pt>
                <c:pt idx="4">
                  <c:v>3.8610817105212898</c:v>
                </c:pt>
                <c:pt idx="5">
                  <c:v>3.4516092861548606</c:v>
                </c:pt>
                <c:pt idx="6">
                  <c:v>10.4714649122401</c:v>
                </c:pt>
                <c:pt idx="7">
                  <c:v>4.40363454799264</c:v>
                </c:pt>
                <c:pt idx="8">
                  <c:v>4.2726801449023304</c:v>
                </c:pt>
                <c:pt idx="9">
                  <c:v>7.7990452529079901</c:v>
                </c:pt>
                <c:pt idx="10">
                  <c:v>4.40363454799264</c:v>
                </c:pt>
                <c:pt idx="11">
                  <c:v>4.0632556034352199</c:v>
                </c:pt>
              </c:numCache>
            </c:numRef>
          </c:xVal>
          <c:yVal>
            <c:numRef>
              <c:f>'[TODO susana.xlsx]d50 (2)'!$R$21:$R$32</c:f>
              <c:numCache>
                <c:formatCode>General</c:formatCode>
                <c:ptCount val="12"/>
                <c:pt idx="0">
                  <c:v>0.75803876662774916</c:v>
                </c:pt>
                <c:pt idx="1">
                  <c:v>-9.7097398576270491E-2</c:v>
                </c:pt>
                <c:pt idx="2">
                  <c:v>0.90762131976351634</c:v>
                </c:pt>
                <c:pt idx="3">
                  <c:v>-0.17547745061437559</c:v>
                </c:pt>
                <c:pt idx="4">
                  <c:v>0.31577421194358268</c:v>
                </c:pt>
                <c:pt idx="5">
                  <c:v>-1.4269219550794858</c:v>
                </c:pt>
                <c:pt idx="6">
                  <c:v>0.30695518369903652</c:v>
                </c:pt>
                <c:pt idx="7">
                  <c:v>-0.67861270167808918</c:v>
                </c:pt>
                <c:pt idx="8">
                  <c:v>1.9815800349439714</c:v>
                </c:pt>
                <c:pt idx="9">
                  <c:v>-0.5100861968548035</c:v>
                </c:pt>
                <c:pt idx="10">
                  <c:v>-0.67861270167808918</c:v>
                </c:pt>
                <c:pt idx="11">
                  <c:v>-0.203707596014958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2DB-4E98-BE40-27B4EAF693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8159728"/>
        <c:axId val="698166384"/>
      </c:scatterChart>
      <c:valAx>
        <c:axId val="698159728"/>
        <c:scaling>
          <c:orientation val="minMax"/>
          <c:max val="1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d50 </a:t>
                </a:r>
                <a:r>
                  <a:rPr lang="en-US" sz="1400" baseline="-25000"/>
                  <a:t>calc</a:t>
                </a:r>
                <a:r>
                  <a:rPr lang="en-US" sz="1400"/>
                  <a:t> (</a:t>
                </a:r>
                <a:r>
                  <a:rPr lang="en-US" sz="1400">
                    <a:latin typeface="Calibri" panose="020F0502020204030204" pitchFamily="34" charset="0"/>
                    <a:cs typeface="Calibri" panose="020F0502020204030204" pitchFamily="34" charset="0"/>
                  </a:rPr>
                  <a:t>µm)</a:t>
                </a:r>
                <a:endParaRPr lang="en-US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66384"/>
        <c:crosses val="autoZero"/>
        <c:crossBetween val="midCat"/>
        <c:majorUnit val="2"/>
      </c:valAx>
      <c:valAx>
        <c:axId val="698166384"/>
        <c:scaling>
          <c:orientation val="minMax"/>
          <c:max val="3"/>
          <c:min val="-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Residuals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59728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67825896762904"/>
          <c:y val="4.2083333333333334E-2"/>
          <c:w val="0.81553696412948384"/>
          <c:h val="0.86532407407407408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TODO susana.xlsx]d90 (2)'!$K$21:$K$32</c:f>
              <c:numCache>
                <c:formatCode>0.00</c:formatCode>
                <c:ptCount val="12"/>
                <c:pt idx="0">
                  <c:v>22.991998436225899</c:v>
                </c:pt>
                <c:pt idx="1">
                  <c:v>28.530972064479201</c:v>
                </c:pt>
                <c:pt idx="2">
                  <c:v>7.825179563598911</c:v>
                </c:pt>
                <c:pt idx="3">
                  <c:v>15.580317906275402</c:v>
                </c:pt>
                <c:pt idx="4">
                  <c:v>5.6923498938553401</c:v>
                </c:pt>
                <c:pt idx="5">
                  <c:v>5.3588910237519487</c:v>
                </c:pt>
                <c:pt idx="6">
                  <c:v>14.9077874300355</c:v>
                </c:pt>
                <c:pt idx="7">
                  <c:v>6.0885990633900802</c:v>
                </c:pt>
                <c:pt idx="8">
                  <c:v>6.7156921940264303</c:v>
                </c:pt>
                <c:pt idx="9">
                  <c:v>10.1601126824806</c:v>
                </c:pt>
                <c:pt idx="10">
                  <c:v>6.0885990633900802</c:v>
                </c:pt>
                <c:pt idx="11">
                  <c:v>6.2637696615532503</c:v>
                </c:pt>
              </c:numCache>
            </c:numRef>
          </c:xVal>
          <c:yVal>
            <c:numRef>
              <c:f>'[TODO susana.xlsx]d90 (2)'!$N$21:$N$32</c:f>
              <c:numCache>
                <c:formatCode>0.00</c:formatCode>
                <c:ptCount val="12"/>
                <c:pt idx="0">
                  <c:v>-9.5331769559233948E-2</c:v>
                </c:pt>
                <c:pt idx="1">
                  <c:v>-0.19430539781253131</c:v>
                </c:pt>
                <c:pt idx="2">
                  <c:v>-7.8512896932243947E-2</c:v>
                </c:pt>
                <c:pt idx="3">
                  <c:v>9.6820937245958305E-3</c:v>
                </c:pt>
                <c:pt idx="4">
                  <c:v>6.7650106144660604E-2</c:v>
                </c:pt>
                <c:pt idx="5">
                  <c:v>1.1089762480507304E-3</c:v>
                </c:pt>
                <c:pt idx="6">
                  <c:v>-1.7787430035498986E-2</c:v>
                </c:pt>
                <c:pt idx="7">
                  <c:v>0.48140093660992012</c:v>
                </c:pt>
                <c:pt idx="8">
                  <c:v>-0.14569219402642997</c:v>
                </c:pt>
                <c:pt idx="9">
                  <c:v>-5.344601581393249E-2</c:v>
                </c:pt>
                <c:pt idx="10">
                  <c:v>0.48140093660992012</c:v>
                </c:pt>
                <c:pt idx="11">
                  <c:v>-0.853769661553250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827-4771-81F7-389A7B84AA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6109072"/>
        <c:axId val="706134032"/>
      </c:scatterChart>
      <c:valAx>
        <c:axId val="706109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/>
                  <a:t>d90 </a:t>
                </a:r>
                <a:r>
                  <a:rPr lang="es-ES" sz="1400" baseline="-25000"/>
                  <a:t>calc</a:t>
                </a:r>
                <a:r>
                  <a:rPr lang="es-ES" sz="1400"/>
                  <a:t> (µm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134032"/>
        <c:crosses val="autoZero"/>
        <c:crossBetween val="midCat"/>
      </c:valAx>
      <c:valAx>
        <c:axId val="706134032"/>
        <c:scaling>
          <c:orientation val="minMax"/>
          <c:max val="3"/>
          <c:min val="-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Residua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10907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69225721784778"/>
          <c:y val="3.2824074074074075E-2"/>
          <c:w val="0.84775218722659673"/>
          <c:h val="0.86532407407407408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TODO susana.xlsx]visc (2)'!$I$21:$I$32</c:f>
              <c:numCache>
                <c:formatCode>General</c:formatCode>
                <c:ptCount val="12"/>
                <c:pt idx="0">
                  <c:v>119.5</c:v>
                </c:pt>
                <c:pt idx="1">
                  <c:v>153.5</c:v>
                </c:pt>
                <c:pt idx="2">
                  <c:v>163.5</c:v>
                </c:pt>
                <c:pt idx="3">
                  <c:v>153.5</c:v>
                </c:pt>
                <c:pt idx="4">
                  <c:v>173</c:v>
                </c:pt>
                <c:pt idx="5">
                  <c:v>181.5</c:v>
                </c:pt>
                <c:pt idx="6">
                  <c:v>163</c:v>
                </c:pt>
                <c:pt idx="7">
                  <c:v>181.5</c:v>
                </c:pt>
                <c:pt idx="8">
                  <c:v>214.5</c:v>
                </c:pt>
                <c:pt idx="9">
                  <c:v>210.5</c:v>
                </c:pt>
                <c:pt idx="10">
                  <c:v>181.5</c:v>
                </c:pt>
                <c:pt idx="11">
                  <c:v>250.5</c:v>
                </c:pt>
              </c:numCache>
            </c:numRef>
          </c:xVal>
          <c:yVal>
            <c:numRef>
              <c:f>'[TODO susana.xlsx]visc (2)'!$N$21:$N$32</c:f>
              <c:numCache>
                <c:formatCode>0.00</c:formatCode>
                <c:ptCount val="12"/>
                <c:pt idx="0">
                  <c:v>-3.3136875227690012</c:v>
                </c:pt>
                <c:pt idx="1">
                  <c:v>2.2469875414080036</c:v>
                </c:pt>
                <c:pt idx="2">
                  <c:v>-0.21289087422599096</c:v>
                </c:pt>
                <c:pt idx="3">
                  <c:v>4.0873751214490142</c:v>
                </c:pt>
                <c:pt idx="4">
                  <c:v>-1.3525971250259943</c:v>
                </c:pt>
                <c:pt idx="5">
                  <c:v>0.22739721716001782</c:v>
                </c:pt>
                <c:pt idx="6">
                  <c:v>1.0242499353940104</c:v>
                </c:pt>
                <c:pt idx="7">
                  <c:v>0.65731558334996976</c:v>
                </c:pt>
                <c:pt idx="8">
                  <c:v>-0.77271290842500662</c:v>
                </c:pt>
                <c:pt idx="9">
                  <c:v>0.67196094246199323</c:v>
                </c:pt>
                <c:pt idx="10">
                  <c:v>0.65731558334996976</c:v>
                </c:pt>
                <c:pt idx="11">
                  <c:v>0.975453213641003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B7F-4AE0-86A8-C208244C3B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6092432"/>
        <c:axId val="706138608"/>
      </c:scatterChart>
      <c:valAx>
        <c:axId val="706092432"/>
        <c:scaling>
          <c:orientation val="minMax"/>
          <c:min val="14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Apparent Viscosity </a:t>
                </a:r>
                <a:r>
                  <a:rPr lang="en-US" sz="1400" baseline="-25000"/>
                  <a:t>calc</a:t>
                </a:r>
                <a:r>
                  <a:rPr lang="en-US" sz="1400"/>
                  <a:t> (mPa·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138608"/>
        <c:crosses val="autoZero"/>
        <c:crossBetween val="midCat"/>
      </c:valAx>
      <c:valAx>
        <c:axId val="706138608"/>
        <c:scaling>
          <c:orientation val="minMax"/>
          <c:min val="-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Residua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09243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02559055118107"/>
          <c:y val="2.9675925925925925E-2"/>
          <c:w val="0.81707666581999816"/>
          <c:h val="0.8606944444444444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TODO susana.xlsx]ci (2)'!$L$21:$L$32</c:f>
              <c:numCache>
                <c:formatCode>0.00</c:formatCode>
                <c:ptCount val="12"/>
                <c:pt idx="0">
                  <c:v>86.110269958534403</c:v>
                </c:pt>
                <c:pt idx="1">
                  <c:v>57.569191505668499</c:v>
                </c:pt>
                <c:pt idx="2">
                  <c:v>35.861031270642002</c:v>
                </c:pt>
                <c:pt idx="3">
                  <c:v>76.944441307994296</c:v>
                </c:pt>
                <c:pt idx="4">
                  <c:v>46.120550128829002</c:v>
                </c:pt>
                <c:pt idx="5">
                  <c:v>47.765129593488901</c:v>
                </c:pt>
                <c:pt idx="6">
                  <c:v>49.802453110979094</c:v>
                </c:pt>
                <c:pt idx="7">
                  <c:v>5.15565462849061</c:v>
                </c:pt>
                <c:pt idx="8">
                  <c:v>0.22656959526753404</c:v>
                </c:pt>
                <c:pt idx="9">
                  <c:v>0.85799882938028904</c:v>
                </c:pt>
                <c:pt idx="10">
                  <c:v>5.15565462849061</c:v>
                </c:pt>
                <c:pt idx="11">
                  <c:v>9.0359396993549404E-2</c:v>
                </c:pt>
              </c:numCache>
            </c:numRef>
          </c:xVal>
          <c:yVal>
            <c:numRef>
              <c:f>'[TODO susana.xlsx]ci (2)'!$P$21:$P$32</c:f>
              <c:numCache>
                <c:formatCode>0.00</c:formatCode>
                <c:ptCount val="12"/>
                <c:pt idx="0">
                  <c:v>1.3397300414656002</c:v>
                </c:pt>
                <c:pt idx="1">
                  <c:v>5.0808494331505472E-2</c:v>
                </c:pt>
                <c:pt idx="2">
                  <c:v>5.5635396024662498E-2</c:v>
                </c:pt>
                <c:pt idx="3">
                  <c:v>-9.4441307994301837E-2</c:v>
                </c:pt>
                <c:pt idx="4">
                  <c:v>-0.22055012882899661</c:v>
                </c:pt>
                <c:pt idx="5">
                  <c:v>8.4870406511100782E-2</c:v>
                </c:pt>
                <c:pt idx="6">
                  <c:v>0.2975468890209001</c:v>
                </c:pt>
                <c:pt idx="7">
                  <c:v>-0.15565462849060996</c:v>
                </c:pt>
                <c:pt idx="8">
                  <c:v>-0.22656959526753404</c:v>
                </c:pt>
                <c:pt idx="9">
                  <c:v>-0.85799882938028904</c:v>
                </c:pt>
                <c:pt idx="10">
                  <c:v>-0.15565462849060996</c:v>
                </c:pt>
                <c:pt idx="11">
                  <c:v>-9.03593969935494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35D-4702-8B11-F959A69614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6098256"/>
        <c:axId val="706081200"/>
      </c:scatterChart>
      <c:valAx>
        <c:axId val="7060982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Creaming index </a:t>
                </a:r>
                <a:r>
                  <a:rPr lang="en-US" sz="1400" baseline="-25000"/>
                  <a:t>calc</a:t>
                </a:r>
                <a:r>
                  <a:rPr lang="en-US" sz="1400"/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081200"/>
        <c:crosses val="autoZero"/>
        <c:crossBetween val="midCat"/>
      </c:valAx>
      <c:valAx>
        <c:axId val="706081200"/>
        <c:scaling>
          <c:orientation val="minMax"/>
          <c:max val="3"/>
          <c:min val="-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Residua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0982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937445319335087E-2"/>
          <c:y val="5.1342592592592606E-2"/>
          <c:w val="0.8458403324584427"/>
          <c:h val="0.84680555555555559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TODO susana.xlsx]potz (2)'!$K$21:$K$32</c:f>
              <c:numCache>
                <c:formatCode>0.00</c:formatCode>
                <c:ptCount val="12"/>
                <c:pt idx="0">
                  <c:v>-38.572077398783897</c:v>
                </c:pt>
                <c:pt idx="1">
                  <c:v>15.8997178146453</c:v>
                </c:pt>
                <c:pt idx="2">
                  <c:v>18.790793982885301</c:v>
                </c:pt>
                <c:pt idx="3">
                  <c:v>-18.005388519977998</c:v>
                </c:pt>
                <c:pt idx="4">
                  <c:v>-12.821647349073098</c:v>
                </c:pt>
                <c:pt idx="5">
                  <c:v>-10.112331588819201</c:v>
                </c:pt>
                <c:pt idx="6">
                  <c:v>-19.087582409558799</c:v>
                </c:pt>
                <c:pt idx="7">
                  <c:v>-15.737161167179101</c:v>
                </c:pt>
                <c:pt idx="8">
                  <c:v>-11.0068519279312</c:v>
                </c:pt>
                <c:pt idx="9">
                  <c:v>-19.435459281891699</c:v>
                </c:pt>
                <c:pt idx="10">
                  <c:v>-15.737161167179101</c:v>
                </c:pt>
                <c:pt idx="11">
                  <c:v>-16.551634224903999</c:v>
                </c:pt>
              </c:numCache>
            </c:numRef>
          </c:xVal>
          <c:yVal>
            <c:numRef>
              <c:f>'[TODO susana.xlsx]potz (2)'!$N$21:$N$32</c:f>
              <c:numCache>
                <c:formatCode>0.00</c:formatCode>
                <c:ptCount val="12"/>
                <c:pt idx="0">
                  <c:v>-2.1999999999999993</c:v>
                </c:pt>
                <c:pt idx="1">
                  <c:v>-2.5000000000000058</c:v>
                </c:pt>
                <c:pt idx="2">
                  <c:v>0.35</c:v>
                </c:pt>
                <c:pt idx="3">
                  <c:v>-1.25</c:v>
                </c:pt>
                <c:pt idx="4">
                  <c:v>-0.2</c:v>
                </c:pt>
                <c:pt idx="5">
                  <c:v>0.39499999999999991</c:v>
                </c:pt>
                <c:pt idx="6">
                  <c:v>-0.12999999999999901</c:v>
                </c:pt>
                <c:pt idx="7">
                  <c:v>-0.90000000000000102</c:v>
                </c:pt>
                <c:pt idx="8">
                  <c:v>-0.13500000000000034</c:v>
                </c:pt>
                <c:pt idx="9">
                  <c:v>-0.37000000000000099</c:v>
                </c:pt>
                <c:pt idx="10">
                  <c:v>-0.90000000000000102</c:v>
                </c:pt>
                <c:pt idx="11">
                  <c:v>-5.000000000000126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8D6-4EA1-9259-C530E51FB0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9409232"/>
        <c:axId val="629412144"/>
      </c:scatterChart>
      <c:valAx>
        <c:axId val="629409232"/>
        <c:scaling>
          <c:orientation val="minMax"/>
          <c:max val="5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Z Potential </a:t>
                </a:r>
                <a:r>
                  <a:rPr lang="en-US" baseline="-25000"/>
                  <a:t>calc</a:t>
                </a:r>
                <a:r>
                  <a:rPr lang="en-US"/>
                  <a:t> (m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9412144"/>
        <c:crosses val="autoZero"/>
        <c:crossBetween val="midCat"/>
      </c:valAx>
      <c:valAx>
        <c:axId val="629412144"/>
        <c:scaling>
          <c:orientation val="minMax"/>
          <c:max val="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siduals</a:t>
                </a:r>
              </a:p>
            </c:rich>
          </c:tx>
          <c:layout>
            <c:manualLayout>
              <c:xMode val="edge"/>
              <c:yMode val="edge"/>
              <c:x val="1.0367891513560806E-2"/>
              <c:y val="0.3425346310877807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940923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7755905511811"/>
          <c:y val="6.5231481481481488E-2"/>
          <c:w val="0.82397440944881895"/>
          <c:h val="0.8292191762337979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TODO susana.xlsx]floc'!$L$21:$L$32</c:f>
              <c:numCache>
                <c:formatCode>0.00</c:formatCode>
                <c:ptCount val="12"/>
                <c:pt idx="0">
                  <c:v>0.74874406488091905</c:v>
                </c:pt>
                <c:pt idx="1">
                  <c:v>66.675036624172094</c:v>
                </c:pt>
                <c:pt idx="2">
                  <c:v>80.679088016341595</c:v>
                </c:pt>
                <c:pt idx="3">
                  <c:v>0.146208640425632</c:v>
                </c:pt>
                <c:pt idx="4">
                  <c:v>50.627135134505203</c:v>
                </c:pt>
                <c:pt idx="5">
                  <c:v>97.223138312580204</c:v>
                </c:pt>
                <c:pt idx="6">
                  <c:v>7.9502353519988994E-2</c:v>
                </c:pt>
                <c:pt idx="7">
                  <c:v>43.302966883738399</c:v>
                </c:pt>
                <c:pt idx="8">
                  <c:v>47.0070267876199</c:v>
                </c:pt>
                <c:pt idx="9">
                  <c:v>0.13566013538383601</c:v>
                </c:pt>
                <c:pt idx="10">
                  <c:v>43.302966883738399</c:v>
                </c:pt>
                <c:pt idx="11">
                  <c:v>33.941555871584299</c:v>
                </c:pt>
              </c:numCache>
            </c:numRef>
          </c:xVal>
          <c:yVal>
            <c:numRef>
              <c:f>'[TODO susana.xlsx]floc'!$P$21:$P$32</c:f>
              <c:numCache>
                <c:formatCode>0.00</c:formatCode>
                <c:ptCount val="12"/>
                <c:pt idx="0">
                  <c:v>-0.74874406488091905</c:v>
                </c:pt>
                <c:pt idx="1">
                  <c:v>0.10163004249457686</c:v>
                </c:pt>
                <c:pt idx="2">
                  <c:v>-7.9088016341600564E-2</c:v>
                </c:pt>
                <c:pt idx="3">
                  <c:v>-0.146208640425632</c:v>
                </c:pt>
                <c:pt idx="4">
                  <c:v>-2.7135134505201108E-2</c:v>
                </c:pt>
                <c:pt idx="5">
                  <c:v>0.526861687419796</c:v>
                </c:pt>
                <c:pt idx="6">
                  <c:v>-7.9502353519988994E-2</c:v>
                </c:pt>
                <c:pt idx="7">
                  <c:v>0.28703311626160399</c:v>
                </c:pt>
                <c:pt idx="8">
                  <c:v>-0.89036012095323258</c:v>
                </c:pt>
                <c:pt idx="9">
                  <c:v>-0.13566013538383601</c:v>
                </c:pt>
                <c:pt idx="10">
                  <c:v>0.28703311626160399</c:v>
                </c:pt>
                <c:pt idx="11">
                  <c:v>0.178444128415698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C24-464B-8427-B5F4170821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9770400"/>
        <c:axId val="749763744"/>
      </c:scatterChart>
      <c:valAx>
        <c:axId val="749770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>
                    <a:solidFill>
                      <a:sysClr val="windowText" lastClr="000000"/>
                    </a:solidFill>
                  </a:rPr>
                  <a:t>Flocculation </a:t>
                </a:r>
                <a:r>
                  <a:rPr lang="es-ES" sz="1400" baseline="-25000">
                    <a:solidFill>
                      <a:sysClr val="windowText" lastClr="000000"/>
                    </a:solidFill>
                  </a:rPr>
                  <a:t>calc</a:t>
                </a:r>
                <a:r>
                  <a:rPr lang="es-ES" sz="1400">
                    <a:solidFill>
                      <a:sysClr val="windowText" lastClr="000000"/>
                    </a:solidFill>
                  </a:rPr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9763744"/>
        <c:crosses val="autoZero"/>
        <c:crossBetween val="midCat"/>
      </c:valAx>
      <c:valAx>
        <c:axId val="749763744"/>
        <c:scaling>
          <c:orientation val="minMax"/>
          <c:max val="3"/>
          <c:min val="-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>
                    <a:solidFill>
                      <a:sysClr val="windowText" lastClr="000000"/>
                    </a:solidFill>
                  </a:rPr>
                  <a:t>Residua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9770400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9771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2391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4030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5482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4593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8144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6710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316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6283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9033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045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D4809F-549E-40B0-9412-0E5F80599CB2}" type="datetimeFigureOut">
              <a:rPr lang="es-ES" smtClean="0"/>
              <a:t>22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34540-7B07-4E45-8F70-AB89AD1E115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4887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n 15" descr="Gráfico, Histograma&#10;&#10;Descripción generada automáticamente">
            <a:extLst>
              <a:ext uri="{FF2B5EF4-FFF2-40B4-BE49-F238E27FC236}">
                <a16:creationId xmlns:a16="http://schemas.microsoft.com/office/drawing/2014/main" id="{0C1250E4-30FC-AC19-771D-038BE547208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205"/>
          <a:stretch/>
        </p:blipFill>
        <p:spPr>
          <a:xfrm>
            <a:off x="10655950" y="8045967"/>
            <a:ext cx="4828342" cy="2322000"/>
          </a:xfrm>
          <a:prstGeom prst="rect">
            <a:avLst/>
          </a:prstGeom>
        </p:spPr>
      </p:pic>
      <p:pic>
        <p:nvPicPr>
          <p:cNvPr id="2" name="Imagen 1" descr="Gráfico, Histograma&#10;&#10;Descripción generada automáticamente">
            <a:extLst>
              <a:ext uri="{FF2B5EF4-FFF2-40B4-BE49-F238E27FC236}">
                <a16:creationId xmlns:a16="http://schemas.microsoft.com/office/drawing/2014/main" id="{88C3DF05-1E38-1D57-2074-8CE0C23B8CA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66"/>
          <a:stretch/>
        </p:blipFill>
        <p:spPr>
          <a:xfrm>
            <a:off x="1816788" y="8109857"/>
            <a:ext cx="4680000" cy="2323262"/>
          </a:xfrm>
          <a:prstGeom prst="rect">
            <a:avLst/>
          </a:prstGeom>
        </p:spPr>
      </p:pic>
      <p:pic>
        <p:nvPicPr>
          <p:cNvPr id="3" name="Imagen 2" descr="Gráfico, Histograma&#10;&#10;Descripción generada automáticamente">
            <a:extLst>
              <a:ext uri="{FF2B5EF4-FFF2-40B4-BE49-F238E27FC236}">
                <a16:creationId xmlns:a16="http://schemas.microsoft.com/office/drawing/2014/main" id="{7EF0FD7E-25F7-DCED-BF5C-A31628FEBE9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66"/>
          <a:stretch/>
        </p:blipFill>
        <p:spPr>
          <a:xfrm>
            <a:off x="6310540" y="8018019"/>
            <a:ext cx="4680000" cy="2323262"/>
          </a:xfrm>
          <a:prstGeom prst="rect">
            <a:avLst/>
          </a:prstGeom>
        </p:spPr>
      </p:pic>
      <p:pic>
        <p:nvPicPr>
          <p:cNvPr id="5" name="Imagen 4" descr="Gráfico, Histograma&#10;&#10;Descripción generada automáticamente">
            <a:extLst>
              <a:ext uri="{FF2B5EF4-FFF2-40B4-BE49-F238E27FC236}">
                <a16:creationId xmlns:a16="http://schemas.microsoft.com/office/drawing/2014/main" id="{87252523-532C-39B6-2EA9-3E9D1D7F69E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67"/>
          <a:stretch/>
        </p:blipFill>
        <p:spPr>
          <a:xfrm>
            <a:off x="3885404" y="5176090"/>
            <a:ext cx="4680000" cy="2323261"/>
          </a:xfrm>
          <a:prstGeom prst="rect">
            <a:avLst/>
          </a:prstGeom>
        </p:spPr>
      </p:pic>
      <p:pic>
        <p:nvPicPr>
          <p:cNvPr id="6" name="Imagen 5" descr="Gráfico, Histograma&#10;&#10;Descripción generada automáticamente">
            <a:extLst>
              <a:ext uri="{FF2B5EF4-FFF2-40B4-BE49-F238E27FC236}">
                <a16:creationId xmlns:a16="http://schemas.microsoft.com/office/drawing/2014/main" id="{2262CB73-9CA3-C8D7-A9AE-BBABBC90CE7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66"/>
          <a:stretch/>
        </p:blipFill>
        <p:spPr>
          <a:xfrm>
            <a:off x="3799679" y="1967867"/>
            <a:ext cx="4680000" cy="2323260"/>
          </a:xfrm>
          <a:prstGeom prst="rect">
            <a:avLst/>
          </a:prstGeom>
        </p:spPr>
      </p:pic>
      <p:pic>
        <p:nvPicPr>
          <p:cNvPr id="7" name="Imagen 6" descr="Gráfico, Histograma&#10;&#10;Descripción generada automáticamente">
            <a:extLst>
              <a:ext uri="{FF2B5EF4-FFF2-40B4-BE49-F238E27FC236}">
                <a16:creationId xmlns:a16="http://schemas.microsoft.com/office/drawing/2014/main" id="{812DD416-D2B8-58D8-F4D7-DB530C9F261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295"/>
          <a:stretch/>
        </p:blipFill>
        <p:spPr>
          <a:xfrm>
            <a:off x="8198984" y="2059247"/>
            <a:ext cx="4680000" cy="2303223"/>
          </a:xfrm>
          <a:prstGeom prst="rect">
            <a:avLst/>
          </a:prstGeom>
        </p:spPr>
      </p:pic>
      <p:pic>
        <p:nvPicPr>
          <p:cNvPr id="8" name="Imagen 7" descr="Gráfico, Histograma&#10;&#10;Descripción generada automáticamente">
            <a:extLst>
              <a:ext uri="{FF2B5EF4-FFF2-40B4-BE49-F238E27FC236}">
                <a16:creationId xmlns:a16="http://schemas.microsoft.com/office/drawing/2014/main" id="{42161979-8F64-DE59-6631-BD79F53BC56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67"/>
          <a:stretch/>
        </p:blipFill>
        <p:spPr>
          <a:xfrm>
            <a:off x="8284709" y="5247433"/>
            <a:ext cx="4680000" cy="2323261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7F9A462B-C7D7-EA66-AF98-97408238C840}"/>
              </a:ext>
            </a:extLst>
          </p:cNvPr>
          <p:cNvSpPr txBox="1"/>
          <p:nvPr/>
        </p:nvSpPr>
        <p:spPr>
          <a:xfrm>
            <a:off x="4071063" y="1689915"/>
            <a:ext cx="339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hapiro test p-</a:t>
            </a:r>
            <a:r>
              <a:rPr lang="es-ES" dirty="0" err="1"/>
              <a:t>value</a:t>
            </a:r>
            <a:r>
              <a:rPr lang="es-ES" dirty="0"/>
              <a:t>= 0.5525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2ADEFB77-882C-8F61-B606-0AAC2D0DFE21}"/>
              </a:ext>
            </a:extLst>
          </p:cNvPr>
          <p:cNvSpPr txBox="1"/>
          <p:nvPr/>
        </p:nvSpPr>
        <p:spPr>
          <a:xfrm>
            <a:off x="8479679" y="1689915"/>
            <a:ext cx="339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hapiro test p-</a:t>
            </a:r>
            <a:r>
              <a:rPr lang="es-ES" dirty="0" err="1"/>
              <a:t>value</a:t>
            </a:r>
            <a:r>
              <a:rPr lang="es-ES" dirty="0"/>
              <a:t>= 0.144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76E3EB83-12F3-3168-A456-91130055677F}"/>
              </a:ext>
            </a:extLst>
          </p:cNvPr>
          <p:cNvSpPr txBox="1"/>
          <p:nvPr/>
        </p:nvSpPr>
        <p:spPr>
          <a:xfrm>
            <a:off x="4195626" y="4787587"/>
            <a:ext cx="339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hapiro test p-</a:t>
            </a:r>
            <a:r>
              <a:rPr lang="es-ES" dirty="0" err="1"/>
              <a:t>value</a:t>
            </a:r>
            <a:r>
              <a:rPr lang="es-ES" dirty="0"/>
              <a:t>= 0.0941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FDACEAFB-4618-4ABD-5211-FE317A85ACA7}"/>
              </a:ext>
            </a:extLst>
          </p:cNvPr>
          <p:cNvSpPr txBox="1"/>
          <p:nvPr/>
        </p:nvSpPr>
        <p:spPr>
          <a:xfrm>
            <a:off x="8565404" y="4852389"/>
            <a:ext cx="339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hapiro test p-</a:t>
            </a:r>
            <a:r>
              <a:rPr lang="es-ES" dirty="0" err="1"/>
              <a:t>value</a:t>
            </a:r>
            <a:r>
              <a:rPr lang="es-ES" dirty="0"/>
              <a:t>= 0.7878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EFA3018-C1CC-C24B-D039-00304020D9D7}"/>
              </a:ext>
            </a:extLst>
          </p:cNvPr>
          <p:cNvSpPr txBox="1"/>
          <p:nvPr/>
        </p:nvSpPr>
        <p:spPr>
          <a:xfrm>
            <a:off x="1935679" y="7726012"/>
            <a:ext cx="339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hapiro test p-</a:t>
            </a:r>
            <a:r>
              <a:rPr lang="es-ES" dirty="0" err="1"/>
              <a:t>value</a:t>
            </a:r>
            <a:r>
              <a:rPr lang="es-ES" dirty="0"/>
              <a:t>= 0.1036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724970D-606E-9C28-47C7-F08578170FE5}"/>
              </a:ext>
            </a:extLst>
          </p:cNvPr>
          <p:cNvSpPr txBox="1"/>
          <p:nvPr/>
        </p:nvSpPr>
        <p:spPr>
          <a:xfrm>
            <a:off x="6588352" y="7740525"/>
            <a:ext cx="339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hapiro test p-</a:t>
            </a:r>
            <a:r>
              <a:rPr lang="es-ES" dirty="0" err="1"/>
              <a:t>value</a:t>
            </a:r>
            <a:r>
              <a:rPr lang="es-ES" dirty="0"/>
              <a:t>= 0.6910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63D85866-6E55-1F54-5AF7-F3C661C5160E}"/>
              </a:ext>
            </a:extLst>
          </p:cNvPr>
          <p:cNvSpPr txBox="1"/>
          <p:nvPr/>
        </p:nvSpPr>
        <p:spPr>
          <a:xfrm>
            <a:off x="11268352" y="7740525"/>
            <a:ext cx="339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Shapiro test p-</a:t>
            </a:r>
            <a:r>
              <a:rPr lang="es-ES" dirty="0" err="1"/>
              <a:t>value</a:t>
            </a:r>
            <a:r>
              <a:rPr lang="es-ES" dirty="0"/>
              <a:t>= 0.4642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9284384-88CB-E599-F67E-8AA4836226D1}"/>
              </a:ext>
            </a:extLst>
          </p:cNvPr>
          <p:cNvSpPr txBox="1"/>
          <p:nvPr/>
        </p:nvSpPr>
        <p:spPr>
          <a:xfrm>
            <a:off x="1816788" y="11530229"/>
            <a:ext cx="1393756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NexusSerif"/>
              </a:rPr>
              <a:t>Figure  S</a:t>
            </a:r>
            <a:r>
              <a:rPr lang="en-US" b="1" i="0" dirty="0">
                <a:effectLst/>
                <a:latin typeface="NexusSerif"/>
              </a:rPr>
              <a:t>3A. </a:t>
            </a:r>
            <a:r>
              <a:rPr lang="en-US" b="0" i="0" dirty="0">
                <a:effectLst/>
                <a:latin typeface="NexusSerif"/>
              </a:rPr>
              <a:t>Histogram of residuals of the emulsions properties: </a:t>
            </a:r>
            <a:r>
              <a:rPr lang="en-US" dirty="0">
                <a:latin typeface="Calibri  "/>
                <a:ea typeface="Calibri" panose="020F0502020204030204" pitchFamily="34" charset="0"/>
                <a:cs typeface="Times New Roman" panose="02020603050405020304" pitchFamily="18" charset="0"/>
              </a:rPr>
              <a:t>percentiles of the droplet size distribution (d10, d50, and d90), flocculation, apparent viscosity, Z potential, and creaming index.</a:t>
            </a:r>
            <a:r>
              <a:rPr lang="en-US" b="0" i="0" dirty="0">
                <a:effectLst/>
                <a:latin typeface="NexusSerif"/>
              </a:rPr>
              <a:t>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207077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>
            <a:extLst>
              <a:ext uri="{FF2B5EF4-FFF2-40B4-BE49-F238E27FC236}">
                <a16:creationId xmlns:a16="http://schemas.microsoft.com/office/drawing/2014/main" id="{3953D078-1670-9BD1-C346-7641BA22A405}"/>
              </a:ext>
            </a:extLst>
          </p:cNvPr>
          <p:cNvGraphicFramePr>
            <a:graphicFrameLocks/>
          </p:cNvGraphicFramePr>
          <p:nvPr/>
        </p:nvGraphicFramePr>
        <p:xfrm>
          <a:off x="1515525" y="658620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áfico 2">
            <a:extLst>
              <a:ext uri="{FF2B5EF4-FFF2-40B4-BE49-F238E27FC236}">
                <a16:creationId xmlns:a16="http://schemas.microsoft.com/office/drawing/2014/main" id="{A77F1F58-7F2F-D402-4DA3-4F8F34D18E47}"/>
              </a:ext>
            </a:extLst>
          </p:cNvPr>
          <p:cNvGraphicFramePr>
            <a:graphicFrameLocks/>
          </p:cNvGraphicFramePr>
          <p:nvPr/>
        </p:nvGraphicFramePr>
        <p:xfrm>
          <a:off x="6344700" y="658620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05EBFE39-3651-A95C-9EBE-D14B57B41AD7}"/>
              </a:ext>
            </a:extLst>
          </p:cNvPr>
          <p:cNvGraphicFramePr>
            <a:graphicFrameLocks/>
          </p:cNvGraphicFramePr>
          <p:nvPr/>
        </p:nvGraphicFramePr>
        <p:xfrm>
          <a:off x="11173875" y="658620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áfico 4">
            <a:extLst>
              <a:ext uri="{FF2B5EF4-FFF2-40B4-BE49-F238E27FC236}">
                <a16:creationId xmlns:a16="http://schemas.microsoft.com/office/drawing/2014/main" id="{59DAE496-0943-1984-BC04-40FB3FD25A5B}"/>
              </a:ext>
            </a:extLst>
          </p:cNvPr>
          <p:cNvGraphicFramePr>
            <a:graphicFrameLocks/>
          </p:cNvGraphicFramePr>
          <p:nvPr/>
        </p:nvGraphicFramePr>
        <p:xfrm>
          <a:off x="3763425" y="52830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EAC20162-CBB2-CB83-30E1-86DB8716D677}"/>
              </a:ext>
            </a:extLst>
          </p:cNvPr>
          <p:cNvGraphicFramePr>
            <a:graphicFrameLocks/>
          </p:cNvGraphicFramePr>
          <p:nvPr/>
        </p:nvGraphicFramePr>
        <p:xfrm>
          <a:off x="8259225" y="3557254"/>
          <a:ext cx="47244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Gráfico 6">
            <a:extLst>
              <a:ext uri="{FF2B5EF4-FFF2-40B4-BE49-F238E27FC236}">
                <a16:creationId xmlns:a16="http://schemas.microsoft.com/office/drawing/2014/main" id="{2B9A3EAD-489B-4B58-1C70-CFD67EF8CE51}"/>
              </a:ext>
            </a:extLst>
          </p:cNvPr>
          <p:cNvGraphicFramePr>
            <a:graphicFrameLocks/>
          </p:cNvGraphicFramePr>
          <p:nvPr/>
        </p:nvGraphicFramePr>
        <p:xfrm>
          <a:off x="8506875" y="52830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Gráfico 7">
            <a:extLst>
              <a:ext uri="{FF2B5EF4-FFF2-40B4-BE49-F238E27FC236}">
                <a16:creationId xmlns:a16="http://schemas.microsoft.com/office/drawing/2014/main" id="{BF1D6F79-120A-3906-7C95-C18722CF61EB}"/>
              </a:ext>
            </a:extLst>
          </p:cNvPr>
          <p:cNvGraphicFramePr>
            <a:graphicFrameLocks/>
          </p:cNvGraphicFramePr>
          <p:nvPr/>
        </p:nvGraphicFramePr>
        <p:xfrm>
          <a:off x="3611025" y="3462003"/>
          <a:ext cx="4724400" cy="2838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9" name="CuadroTexto 8">
            <a:extLst>
              <a:ext uri="{FF2B5EF4-FFF2-40B4-BE49-F238E27FC236}">
                <a16:creationId xmlns:a16="http://schemas.microsoft.com/office/drawing/2014/main" id="{4C002BBC-EF30-0392-BFF1-976628876585}"/>
              </a:ext>
            </a:extLst>
          </p:cNvPr>
          <p:cNvSpPr txBox="1"/>
          <p:nvPr/>
        </p:nvSpPr>
        <p:spPr>
          <a:xfrm>
            <a:off x="1816788" y="11530229"/>
            <a:ext cx="1515676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NexusSerif"/>
              </a:rPr>
              <a:t>Figure  S3B.</a:t>
            </a:r>
            <a:r>
              <a:rPr lang="en-US" b="0" i="0" dirty="0">
                <a:effectLst/>
                <a:latin typeface="NexusSerif"/>
              </a:rPr>
              <a:t> Residuals </a:t>
            </a:r>
            <a:r>
              <a:rPr lang="en-US" dirty="0">
                <a:latin typeface="NexusSerif"/>
              </a:rPr>
              <a:t>vs calculated values of the </a:t>
            </a:r>
            <a:r>
              <a:rPr lang="en-US" b="0" i="0" dirty="0">
                <a:effectLst/>
                <a:latin typeface="NexusSerif"/>
              </a:rPr>
              <a:t>emulsions properties: </a:t>
            </a:r>
            <a:r>
              <a:rPr lang="en-US" dirty="0">
                <a:latin typeface="Calibri  "/>
                <a:ea typeface="Calibri" panose="020F0502020204030204" pitchFamily="34" charset="0"/>
                <a:cs typeface="Times New Roman" panose="02020603050405020304" pitchFamily="18" charset="0"/>
              </a:rPr>
              <a:t>percentiles of the droplet size distribution (d10, d50, and d90), flocculation, apparent viscosity, Z potential, and creaming index.</a:t>
            </a:r>
            <a:r>
              <a:rPr lang="en-US" b="0" i="0" dirty="0">
                <a:effectLst/>
                <a:latin typeface="NexusSerif"/>
              </a:rPr>
              <a:t>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891663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54</TotalTime>
  <Words>153</Words>
  <Application>Microsoft Office PowerPoint</Application>
  <PresentationFormat>Custom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Calibri  </vt:lpstr>
      <vt:lpstr>NexusSerif</vt:lpstr>
      <vt:lpstr>Arial</vt:lpstr>
      <vt:lpstr>Calibri</vt:lpstr>
      <vt:lpstr>Calibri Light</vt:lpstr>
      <vt:lpstr>Times New Roman</vt:lpstr>
      <vt:lpstr>Tema d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onica maria umaña zamora</dc:creator>
  <cp:lastModifiedBy>MDPI</cp:lastModifiedBy>
  <cp:revision>8</cp:revision>
  <dcterms:created xsi:type="dcterms:W3CDTF">2022-10-05T07:13:38Z</dcterms:created>
  <dcterms:modified xsi:type="dcterms:W3CDTF">2022-11-22T08:52:25Z</dcterms:modified>
</cp:coreProperties>
</file>